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CD1AA0-8461-4861-B172-9D1C1614F16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488671-56F0-4025-8ABA-AA057B1C65A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3D6480-4662-4309-8E7E-E73ABEE0136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B6DCE3-1CAA-4BCF-AAC4-17098F94D84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 rtl="1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4545B8-A068-455C-9671-2E291CB0911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F76DB1-6D56-4395-97C9-E8CD3B7A0A5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839442-7B79-46D8-A21F-422D805C386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D9BC51-BB3E-4E0F-80C8-2D9C360DCB8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 rtl="1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EB23EA-7B97-4A12-A660-94EB53A6A6E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F3C6A4-0763-4F49-870A-BB6C760CAC5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3ED237-3E76-4EB6-A79D-9B06F44AA2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873BC0-96DC-40A8-A598-B6A740FF0E2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48CC44E-D005-4477-B3B3-C35A4ABF678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34920" y="115920"/>
            <a:ext cx="9650160" cy="6605640"/>
            <a:chOff x="34920" y="115920"/>
            <a:chExt cx="9650160" cy="6605640"/>
          </a:xfrm>
        </p:grpSpPr>
        <p:pic>
          <p:nvPicPr>
            <p:cNvPr id="42" name="Picture 18" descr="uxp_03_ixp_01"/>
            <p:cNvPicPr/>
            <p:nvPr/>
          </p:nvPicPr>
          <p:blipFill>
            <a:blip r:embed="rId1"/>
            <a:stretch/>
          </p:blipFill>
          <p:spPr>
            <a:xfrm>
              <a:off x="3502080" y="150840"/>
              <a:ext cx="3892320" cy="2414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Picture 16" descr="uxp_01_ixp_0033"/>
            <p:cNvPicPr/>
            <p:nvPr/>
          </p:nvPicPr>
          <p:blipFill>
            <a:blip r:embed="rId2"/>
            <a:stretch/>
          </p:blipFill>
          <p:spPr>
            <a:xfrm>
              <a:off x="158760" y="150840"/>
              <a:ext cx="3692520" cy="2405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"/>
            <p:cNvSpPr/>
            <p:nvPr/>
          </p:nvSpPr>
          <p:spPr>
            <a:xfrm>
              <a:off x="4097160" y="2303640"/>
              <a:ext cx="2675160" cy="1364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34920" y="316080"/>
              <a:ext cx="277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rtl="1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1731960" y="2638440"/>
              <a:ext cx="407880" cy="135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1755720" y="150840"/>
              <a:ext cx="407880" cy="135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5213520" y="150840"/>
              <a:ext cx="407880" cy="135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255600" y="3746520"/>
              <a:ext cx="149040" cy="1490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244440" y="1203480"/>
              <a:ext cx="149400" cy="1490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604800" y="2284560"/>
              <a:ext cx="2674800" cy="196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3622680" y="1203480"/>
              <a:ext cx="149400" cy="1490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3622680" y="3724200"/>
              <a:ext cx="149400" cy="1494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3838680" y="6599160"/>
              <a:ext cx="118800" cy="1224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5" name=""/>
            <p:cNvGrpSpPr/>
            <p:nvPr/>
          </p:nvGrpSpPr>
          <p:grpSpPr>
            <a:xfrm>
              <a:off x="139680" y="2349360"/>
              <a:ext cx="3692520" cy="2454480"/>
              <a:chOff x="139680" y="2349360"/>
              <a:chExt cx="3692520" cy="2454480"/>
            </a:xfrm>
          </p:grpSpPr>
          <p:grpSp>
            <p:nvGrpSpPr>
              <p:cNvPr id="56" name=""/>
              <p:cNvGrpSpPr/>
              <p:nvPr/>
            </p:nvGrpSpPr>
            <p:grpSpPr>
              <a:xfrm>
                <a:off x="139680" y="2349360"/>
                <a:ext cx="3692520" cy="2454480"/>
                <a:chOff x="139680" y="2349360"/>
                <a:chExt cx="3692520" cy="2454480"/>
              </a:xfrm>
            </p:grpSpPr>
            <p:pic>
              <p:nvPicPr>
                <p:cNvPr id="57" name="Picture 17" descr="uxp_01_ixp_0066"/>
                <p:cNvPicPr/>
                <p:nvPr/>
              </p:nvPicPr>
              <p:blipFill>
                <a:blip r:embed="rId3"/>
                <a:stretch/>
              </p:blipFill>
              <p:spPr>
                <a:xfrm>
                  <a:off x="139680" y="2349360"/>
                  <a:ext cx="3692520" cy="240516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58" name=""/>
                <p:cNvSpPr/>
                <p:nvPr/>
              </p:nvSpPr>
              <p:spPr>
                <a:xfrm>
                  <a:off x="1957320" y="4654440"/>
                  <a:ext cx="149400" cy="14940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 algn="r" rtl="1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59" name=""/>
              <p:cNvSpPr/>
              <p:nvPr/>
            </p:nvSpPr>
            <p:spPr>
              <a:xfrm>
                <a:off x="1827360" y="2373120"/>
                <a:ext cx="503280" cy="1018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0" name=""/>
            <p:cNvGrpSpPr/>
            <p:nvPr/>
          </p:nvGrpSpPr>
          <p:grpSpPr>
            <a:xfrm>
              <a:off x="3492360" y="2349360"/>
              <a:ext cx="3892680" cy="2457720"/>
              <a:chOff x="3492360" y="2349360"/>
              <a:chExt cx="3892680" cy="2457720"/>
            </a:xfrm>
          </p:grpSpPr>
          <p:grpSp>
            <p:nvGrpSpPr>
              <p:cNvPr id="61" name=""/>
              <p:cNvGrpSpPr/>
              <p:nvPr/>
            </p:nvGrpSpPr>
            <p:grpSpPr>
              <a:xfrm>
                <a:off x="3492360" y="2349360"/>
                <a:ext cx="3892680" cy="2457720"/>
                <a:chOff x="3492360" y="2349360"/>
                <a:chExt cx="3892680" cy="2457720"/>
              </a:xfrm>
            </p:grpSpPr>
            <p:pic>
              <p:nvPicPr>
                <p:cNvPr id="62" name="Picture 19" descr="uxp_03_ixp_02"/>
                <p:cNvPicPr/>
                <p:nvPr/>
              </p:nvPicPr>
              <p:blipFill>
                <a:blip r:embed="rId4"/>
                <a:stretch/>
              </p:blipFill>
              <p:spPr>
                <a:xfrm>
                  <a:off x="3492360" y="2349360"/>
                  <a:ext cx="3892680" cy="24354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63" name=""/>
                <p:cNvSpPr/>
                <p:nvPr/>
              </p:nvSpPr>
              <p:spPr>
                <a:xfrm>
                  <a:off x="5432400" y="4657680"/>
                  <a:ext cx="149400" cy="14940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 algn="r" rtl="1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64" name=""/>
              <p:cNvSpPr/>
              <p:nvPr/>
            </p:nvSpPr>
            <p:spPr>
              <a:xfrm>
                <a:off x="5229360" y="2354400"/>
                <a:ext cx="503280" cy="1015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5" name=""/>
            <p:cNvSpPr/>
            <p:nvPr/>
          </p:nvSpPr>
          <p:spPr>
            <a:xfrm>
              <a:off x="34920" y="2506680"/>
              <a:ext cx="277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rtl="1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6" name=""/>
            <p:cNvGrpSpPr/>
            <p:nvPr/>
          </p:nvGrpSpPr>
          <p:grpSpPr>
            <a:xfrm>
              <a:off x="7043760" y="1785960"/>
              <a:ext cx="2641320" cy="1427040"/>
              <a:chOff x="7043760" y="1785960"/>
              <a:chExt cx="2641320" cy="1427040"/>
            </a:xfrm>
          </p:grpSpPr>
          <p:pic>
            <p:nvPicPr>
              <p:cNvPr id="67" name="Picture 10" descr=""/>
              <p:cNvPicPr/>
              <p:nvPr/>
            </p:nvPicPr>
            <p:blipFill>
              <a:blip r:embed="rId5"/>
              <a:srcRect l="3779" t="0" r="79365" b="0"/>
              <a:stretch/>
            </p:blipFill>
            <p:spPr>
              <a:xfrm>
                <a:off x="7043760" y="1785960"/>
                <a:ext cx="365040" cy="14270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8" name=""/>
              <p:cNvSpPr/>
              <p:nvPr/>
            </p:nvSpPr>
            <p:spPr>
              <a:xfrm>
                <a:off x="7356240" y="1844640"/>
                <a:ext cx="18734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Invasions fail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7356240" y="2133360"/>
                <a:ext cx="23050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FAD reaches polymorphism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7356240" y="2465280"/>
                <a:ext cx="23050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FAD takes over; UNI fail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7380360" y="2781360"/>
                <a:ext cx="2304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FAD and UNI take over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2" name=""/>
            <p:cNvSpPr/>
            <p:nvPr/>
          </p:nvSpPr>
          <p:spPr>
            <a:xfrm>
              <a:off x="387360" y="2637000"/>
              <a:ext cx="233280" cy="17398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392040" y="411120"/>
              <a:ext cx="247680" cy="17398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3780000" y="2630520"/>
              <a:ext cx="210960" cy="1803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3789360" y="404640"/>
              <a:ext cx="216000" cy="17924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798480" y="4500720"/>
              <a:ext cx="2513160" cy="169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4191120" y="4518000"/>
              <a:ext cx="2655720" cy="223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8" name=""/>
            <p:cNvGrpSpPr/>
            <p:nvPr/>
          </p:nvGrpSpPr>
          <p:grpSpPr>
            <a:xfrm>
              <a:off x="47520" y="339840"/>
              <a:ext cx="622080" cy="2009160"/>
              <a:chOff x="47520" y="339840"/>
              <a:chExt cx="622080" cy="2009160"/>
            </a:xfrm>
          </p:grpSpPr>
          <p:sp>
            <p:nvSpPr>
              <p:cNvPr id="79" name=""/>
              <p:cNvSpPr/>
              <p:nvPr/>
            </p:nvSpPr>
            <p:spPr>
              <a:xfrm rot="16200000">
                <a:off x="-760680" y="1263960"/>
                <a:ext cx="18936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Cost of dispersal (</a:t>
                </a: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c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80" name=""/>
              <p:cNvGrpSpPr/>
              <p:nvPr/>
            </p:nvGrpSpPr>
            <p:grpSpPr>
              <a:xfrm>
                <a:off x="264960" y="339840"/>
                <a:ext cx="404640" cy="1917720"/>
                <a:chOff x="264960" y="339840"/>
                <a:chExt cx="404640" cy="1917720"/>
              </a:xfrm>
            </p:grpSpPr>
            <p:sp>
              <p:nvSpPr>
                <p:cNvPr id="81" name=""/>
                <p:cNvSpPr/>
                <p:nvPr/>
              </p:nvSpPr>
              <p:spPr>
                <a:xfrm>
                  <a:off x="264960" y="1620720"/>
                  <a:ext cx="4046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 rtl="1"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0.1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" name=""/>
                <p:cNvSpPr/>
                <p:nvPr/>
              </p:nvSpPr>
              <p:spPr>
                <a:xfrm>
                  <a:off x="264960" y="1279440"/>
                  <a:ext cx="4046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 rtl="1"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0.2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" name=""/>
                <p:cNvSpPr/>
                <p:nvPr/>
              </p:nvSpPr>
              <p:spPr>
                <a:xfrm>
                  <a:off x="264960" y="955440"/>
                  <a:ext cx="4046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 rtl="1"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0.3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" name=""/>
                <p:cNvSpPr/>
                <p:nvPr/>
              </p:nvSpPr>
              <p:spPr>
                <a:xfrm>
                  <a:off x="264960" y="652320"/>
                  <a:ext cx="4046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 rtl="1"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0.4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" name=""/>
                <p:cNvSpPr/>
                <p:nvPr/>
              </p:nvSpPr>
              <p:spPr>
                <a:xfrm>
                  <a:off x="264960" y="339840"/>
                  <a:ext cx="4046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 rtl="1"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0.5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" name=""/>
                <p:cNvSpPr/>
                <p:nvPr/>
              </p:nvSpPr>
              <p:spPr>
                <a:xfrm>
                  <a:off x="264960" y="1981080"/>
                  <a:ext cx="4046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 rtl="1"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87" name=""/>
            <p:cNvGrpSpPr/>
            <p:nvPr/>
          </p:nvGrpSpPr>
          <p:grpSpPr>
            <a:xfrm>
              <a:off x="4081320" y="4437000"/>
              <a:ext cx="2795760" cy="497160"/>
              <a:chOff x="4081320" y="4437000"/>
              <a:chExt cx="2795760" cy="497160"/>
            </a:xfrm>
          </p:grpSpPr>
          <p:sp>
            <p:nvSpPr>
              <p:cNvPr id="88" name=""/>
              <p:cNvSpPr/>
              <p:nvPr/>
            </p:nvSpPr>
            <p:spPr>
              <a:xfrm>
                <a:off x="4410000" y="4657680"/>
                <a:ext cx="2163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Dominance coefficient (</a:t>
                </a: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h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89" name=""/>
              <p:cNvGrpSpPr/>
              <p:nvPr/>
            </p:nvGrpSpPr>
            <p:grpSpPr>
              <a:xfrm>
                <a:off x="4081320" y="4437000"/>
                <a:ext cx="2795760" cy="276480"/>
                <a:chOff x="4081320" y="4437000"/>
                <a:chExt cx="2795760" cy="276480"/>
              </a:xfrm>
            </p:grpSpPr>
            <p:sp>
              <p:nvSpPr>
                <p:cNvPr id="90" name=""/>
                <p:cNvSpPr/>
                <p:nvPr/>
              </p:nvSpPr>
              <p:spPr>
                <a:xfrm>
                  <a:off x="4729320" y="4437000"/>
                  <a:ext cx="4190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 rtl="1"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0.2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" name=""/>
                <p:cNvSpPr/>
                <p:nvPr/>
              </p:nvSpPr>
              <p:spPr>
                <a:xfrm>
                  <a:off x="4081320" y="4437000"/>
                  <a:ext cx="4194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 rtl="1"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0.1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" name=""/>
                <p:cNvSpPr/>
                <p:nvPr/>
              </p:nvSpPr>
              <p:spPr>
                <a:xfrm>
                  <a:off x="5280120" y="4437000"/>
                  <a:ext cx="4190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 rtl="1"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0.3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" name=""/>
                <p:cNvSpPr/>
                <p:nvPr/>
              </p:nvSpPr>
              <p:spPr>
                <a:xfrm>
                  <a:off x="5867280" y="4437000"/>
                  <a:ext cx="4194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 rtl="1"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0.4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" name=""/>
                <p:cNvSpPr/>
                <p:nvPr/>
              </p:nvSpPr>
              <p:spPr>
                <a:xfrm>
                  <a:off x="6458040" y="4437000"/>
                  <a:ext cx="4190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 rtl="1"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0.5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95" name=""/>
            <p:cNvGrpSpPr/>
            <p:nvPr/>
          </p:nvGrpSpPr>
          <p:grpSpPr>
            <a:xfrm>
              <a:off x="684360" y="4437000"/>
              <a:ext cx="2795040" cy="497160"/>
              <a:chOff x="684360" y="4437000"/>
              <a:chExt cx="2795040" cy="497160"/>
            </a:xfrm>
          </p:grpSpPr>
          <p:sp>
            <p:nvSpPr>
              <p:cNvPr id="96" name=""/>
              <p:cNvSpPr/>
              <p:nvPr/>
            </p:nvSpPr>
            <p:spPr>
              <a:xfrm>
                <a:off x="1012680" y="4657680"/>
                <a:ext cx="21636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Dominance coefficient (</a:t>
                </a: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h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97" name=""/>
              <p:cNvGrpSpPr/>
              <p:nvPr/>
            </p:nvGrpSpPr>
            <p:grpSpPr>
              <a:xfrm>
                <a:off x="684360" y="4437000"/>
                <a:ext cx="2795040" cy="276480"/>
                <a:chOff x="684360" y="4437000"/>
                <a:chExt cx="2795040" cy="276480"/>
              </a:xfrm>
            </p:grpSpPr>
            <p:sp>
              <p:nvSpPr>
                <p:cNvPr id="98" name=""/>
                <p:cNvSpPr/>
                <p:nvPr/>
              </p:nvSpPr>
              <p:spPr>
                <a:xfrm>
                  <a:off x="1332000" y="4437000"/>
                  <a:ext cx="4186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 rtl="1"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0.2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" name=""/>
                <p:cNvSpPr/>
                <p:nvPr/>
              </p:nvSpPr>
              <p:spPr>
                <a:xfrm>
                  <a:off x="684360" y="4437000"/>
                  <a:ext cx="4190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 rtl="1"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0.1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" name=""/>
                <p:cNvSpPr/>
                <p:nvPr/>
              </p:nvSpPr>
              <p:spPr>
                <a:xfrm>
                  <a:off x="1882800" y="4437000"/>
                  <a:ext cx="4186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 rtl="1"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0.3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" name=""/>
                <p:cNvSpPr/>
                <p:nvPr/>
              </p:nvSpPr>
              <p:spPr>
                <a:xfrm>
                  <a:off x="2469960" y="4437000"/>
                  <a:ext cx="4190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 rtl="1"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0.4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" name=""/>
                <p:cNvSpPr/>
                <p:nvPr/>
              </p:nvSpPr>
              <p:spPr>
                <a:xfrm>
                  <a:off x="3060720" y="4437000"/>
                  <a:ext cx="4186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 rtl="1"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0.5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103" name=""/>
            <p:cNvGrpSpPr/>
            <p:nvPr/>
          </p:nvGrpSpPr>
          <p:grpSpPr>
            <a:xfrm>
              <a:off x="34920" y="2571840"/>
              <a:ext cx="622080" cy="2009160"/>
              <a:chOff x="34920" y="2571840"/>
              <a:chExt cx="622080" cy="2009160"/>
            </a:xfrm>
          </p:grpSpPr>
          <p:sp>
            <p:nvSpPr>
              <p:cNvPr id="104" name=""/>
              <p:cNvSpPr/>
              <p:nvPr/>
            </p:nvSpPr>
            <p:spPr>
              <a:xfrm rot="16200000">
                <a:off x="-773280" y="3495960"/>
                <a:ext cx="18936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Cost of dispersal (</a:t>
                </a: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c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05" name=""/>
              <p:cNvGrpSpPr/>
              <p:nvPr/>
            </p:nvGrpSpPr>
            <p:grpSpPr>
              <a:xfrm>
                <a:off x="252360" y="2571840"/>
                <a:ext cx="404640" cy="1917720"/>
                <a:chOff x="252360" y="2571840"/>
                <a:chExt cx="404640" cy="1917720"/>
              </a:xfrm>
            </p:grpSpPr>
            <p:sp>
              <p:nvSpPr>
                <p:cNvPr id="106" name=""/>
                <p:cNvSpPr/>
                <p:nvPr/>
              </p:nvSpPr>
              <p:spPr>
                <a:xfrm>
                  <a:off x="252360" y="3852720"/>
                  <a:ext cx="4046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 rtl="1"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0.1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" name=""/>
                <p:cNvSpPr/>
                <p:nvPr/>
              </p:nvSpPr>
              <p:spPr>
                <a:xfrm>
                  <a:off x="252360" y="3511440"/>
                  <a:ext cx="4046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 rtl="1"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0.2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" name=""/>
                <p:cNvSpPr/>
                <p:nvPr/>
              </p:nvSpPr>
              <p:spPr>
                <a:xfrm>
                  <a:off x="252360" y="3187440"/>
                  <a:ext cx="4046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 rtl="1"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0.3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" name=""/>
                <p:cNvSpPr/>
                <p:nvPr/>
              </p:nvSpPr>
              <p:spPr>
                <a:xfrm>
                  <a:off x="252360" y="2884320"/>
                  <a:ext cx="4046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 rtl="1"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0.4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" name=""/>
                <p:cNvSpPr/>
                <p:nvPr/>
              </p:nvSpPr>
              <p:spPr>
                <a:xfrm>
                  <a:off x="252360" y="2571840"/>
                  <a:ext cx="4046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 rtl="1"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0.5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" name=""/>
                <p:cNvSpPr/>
                <p:nvPr/>
              </p:nvSpPr>
              <p:spPr>
                <a:xfrm>
                  <a:off x="252360" y="4213080"/>
                  <a:ext cx="4046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 rtl="1"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112" name=""/>
            <p:cNvSpPr/>
            <p:nvPr/>
          </p:nvSpPr>
          <p:spPr>
            <a:xfrm>
              <a:off x="1979640" y="115920"/>
              <a:ext cx="431640" cy="144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5364000" y="115920"/>
              <a:ext cx="432000" cy="144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3646440" y="316080"/>
              <a:ext cx="277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rtl="1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3646440" y="2484360"/>
              <a:ext cx="277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rtl="1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4-22T09:33:12Z</dcterms:created>
  <dc:creator>LHadany2</dc:creator>
  <dc:description/>
  <dc:language>en-US</dc:language>
  <cp:lastModifiedBy>C107</cp:lastModifiedBy>
  <dcterms:modified xsi:type="dcterms:W3CDTF">2013-06-12T11:20:13Z</dcterms:modified>
  <cp:revision>20</cp:revision>
  <dc:subject/>
  <dc:title>Slide 1</dc:title>
</cp:coreProperties>
</file>